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0"/>
  </p:notes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31" d="100"/>
          <a:sy n="131" d="100"/>
        </p:scale>
        <p:origin x="906" y="12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EEF891-B09B-46C9-AB30-9E0B949C6379}" type="datetimeFigureOut">
              <a:rPr lang="en-GB" smtClean="0"/>
              <a:t>21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A1E948-7BD9-4BD8-AE14-F89B946A1B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4883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A1E948-7BD9-4BD8-AE14-F89B946A1B0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89485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A1E948-7BD9-4BD8-AE14-F89B946A1B08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99440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A1E948-7BD9-4BD8-AE14-F89B946A1B08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41332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A1E948-7BD9-4BD8-AE14-F89B946A1B08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860987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A1E948-7BD9-4BD8-AE14-F89B946A1B08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22780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A1E948-7BD9-4BD8-AE14-F89B946A1B08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16113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21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84106"/>
            <a:ext cx="7772400" cy="1378095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3000" dirty="0">
                <a:latin typeface="Calibri" panose="020F0502020204030204" pitchFamily="34" charset="0"/>
                <a:cs typeface="Calibri" panose="020F0502020204030204" pitchFamily="34" charset="0"/>
              </a:rPr>
              <a:t>[</a:t>
            </a:r>
            <a:r>
              <a:rPr lang="en-US" sz="30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sz="3000" dirty="0">
                <a:latin typeface="Calibri" panose="020F0502020204030204" pitchFamily="34" charset="0"/>
                <a:cs typeface="Calibri" panose="020F0502020204030204" pitchFamily="34" charset="0"/>
              </a:rPr>
              <a:t>Cu]Cu-DOTATATE PET metrics in the investigation of </a:t>
            </a:r>
            <a:r>
              <a:rPr lang="en-US" sz="3000" dirty="0" smtClean="0">
                <a:latin typeface="Calibri" panose="020F0502020204030204" pitchFamily="34" charset="0"/>
                <a:cs typeface="Calibri" panose="020F0502020204030204" pitchFamily="34" charset="0"/>
              </a:rPr>
              <a:t>atherosclerotic inflammation </a:t>
            </a:r>
            <a:r>
              <a:rPr lang="en-US" sz="3000" dirty="0">
                <a:latin typeface="Calibri" panose="020F0502020204030204" pitchFamily="34" charset="0"/>
                <a:cs typeface="Calibri" panose="020F0502020204030204" pitchFamily="34" charset="0"/>
              </a:rPr>
              <a:t>in humans</a:t>
            </a:r>
            <a:endParaRPr lang="en-US" altLang="en-US" sz="30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838200" y="2476077"/>
            <a:ext cx="73152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Jacob K. Jensen, MD,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Johanne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 S. Madsen, MD,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Malte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 E.K. Jensen, MSc, Andreas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Kjaer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MD,PhD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DMSc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Rasmus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 S.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Ripa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, MD, </a:t>
            </a:r>
            <a:r>
              <a:rPr lang="en-US" altLang="en-US" sz="1800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DMSc</a:t>
            </a:r>
            <a:endParaRPr lang="en-US" altLang="en-US" sz="18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lvl="1"/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Department of Clinical Physiology and Nuclear Medicine &amp; Cluster for Molecular Imaging,</a:t>
            </a:r>
            <a:b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Copenhagen University Hospital – Rigshospitalet &amp; Department of Biomedical Sciences, University of</a:t>
            </a:r>
            <a:b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Copenhagen, Denmark</a:t>
            </a:r>
            <a:endParaRPr lang="en-US" altLang="en-US" sz="10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7400" y="3985626"/>
            <a:ext cx="1456532" cy="194204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7800" y="3983942"/>
            <a:ext cx="1676400" cy="83593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7800" y="5292248"/>
            <a:ext cx="1859280" cy="53949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Calibri" panose="020F0502020204030204" pitchFamily="34" charset="0"/>
                <a:cs typeface="Calibri" panose="020F0502020204030204" pitchFamily="34" charset="0"/>
              </a:rPr>
              <a:t>BACKGROUND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Somatostatin receptor (SSTR) PET imaging as a marker for activated macrophage activity has previously been validated.</a:t>
            </a:r>
            <a:b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endParaRPr lang="en-US" altLang="en-US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[</a:t>
            </a:r>
            <a:r>
              <a:rPr lang="en-US" altLang="en-US" sz="1600" baseline="30000" dirty="0" smtClean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u]Cu-DOTATATE, a radiolabeled SSTR analog, primarily used in neuroendocrine neoplasm imaging, can also be used to asses atherosclerotic inflammation </a:t>
            </a:r>
            <a:r>
              <a:rPr lang="en-US" altLang="en-US" sz="16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in vivo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b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endParaRPr lang="en-US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[</a:t>
            </a:r>
            <a:r>
              <a:rPr lang="en-US" altLang="en-US" sz="1600" baseline="30000" dirty="0" smtClean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u]Cu-DOTATATE has not previously been evaluated in patient groups with different severity of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cardiovascular disease (CVD)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endParaRPr lang="en-US" altLang="en-US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000" dirty="0" smtClean="0">
                <a:latin typeface="Calibri" panose="020F0502020204030204" pitchFamily="34" charset="0"/>
                <a:cs typeface="Calibri" panose="020F0502020204030204" pitchFamily="34" charset="0"/>
              </a:rPr>
              <a:t>Aims </a:t>
            </a:r>
            <a:r>
              <a:rPr lang="en-US" altLang="en-US" sz="2000" dirty="0" smtClean="0">
                <a:latin typeface="Calibri" panose="020F0502020204030204" pitchFamily="34" charset="0"/>
                <a:cs typeface="Calibri" panose="020F0502020204030204" pitchFamily="34" charset="0"/>
              </a:rPr>
              <a:t>of this </a:t>
            </a:r>
            <a:r>
              <a:rPr lang="en-US" altLang="en-US" sz="2000" dirty="0" smtClean="0">
                <a:latin typeface="Calibri" panose="020F0502020204030204" pitchFamily="34" charset="0"/>
                <a:cs typeface="Calibri" panose="020F0502020204030204" pitchFamily="34" charset="0"/>
              </a:rPr>
              <a:t>study: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The primary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aim of this study was to assess and compare the arterial uptake of the inflammatory macrophage targeting PET tracer [</a:t>
            </a:r>
            <a:r>
              <a:rPr lang="en-US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Cu]Cu-DOTATATE in patients with no or known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VD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to investigate potential differences in uptake. </a:t>
            </a:r>
            <a:endParaRPr lang="en-US" altLang="en-US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METHODS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19100" y="1464468"/>
            <a:ext cx="83058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US" alt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Study </a:t>
            </a:r>
            <a:r>
              <a:rPr lang="en-US" altLang="en-US" sz="2000" dirty="0" smtClean="0">
                <a:latin typeface="Calibri" panose="020F0502020204030204" pitchFamily="34" charset="0"/>
                <a:cs typeface="Calibri" panose="020F0502020204030204" pitchFamily="34" charset="0"/>
              </a:rPr>
              <a:t>type:</a:t>
            </a:r>
            <a:r>
              <a:rPr lang="en-US" altLang="en-US" sz="2800" dirty="0" smtClean="0">
                <a:latin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altLang="en-US" sz="28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 retrospective cohort study.</a:t>
            </a:r>
            <a:endParaRPr lang="en-US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000" dirty="0" smtClean="0">
                <a:latin typeface="Calibri" panose="020F0502020204030204" pitchFamily="34" charset="0"/>
                <a:cs typeface="Calibri" panose="020F0502020204030204" pitchFamily="34" charset="0"/>
              </a:rPr>
              <a:t>Study subjects:</a:t>
            </a:r>
            <a:r>
              <a:rPr lang="en-US" altLang="en-US" sz="2800" dirty="0" smtClean="0">
                <a:latin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altLang="en-US" sz="28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Patients with neuroendocrine neoplasms and pre-defined different degrees of known cardiovascular risk/disease who had undergone a [</a:t>
            </a:r>
            <a:r>
              <a:rPr lang="en-US" altLang="en-US" sz="1600" baseline="30000" dirty="0" smtClean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u]Cu-DOTATATE PET/CT scan. Patients were allocated to one of three groups: 1) No known risk factors </a:t>
            </a:r>
            <a:r>
              <a:rPr lang="en-US" altLang="en-US" sz="1600" smtClean="0">
                <a:latin typeface="Calibri" panose="020F0502020204030204" pitchFamily="34" charset="0"/>
                <a:cs typeface="Calibri" panose="020F0502020204030204" pitchFamily="34" charset="0"/>
              </a:rPr>
              <a:t>for </a:t>
            </a:r>
            <a:r>
              <a:rPr lang="en-US" altLang="en-US" sz="1600" smtClean="0">
                <a:latin typeface="Calibri" panose="020F0502020204030204" pitchFamily="34" charset="0"/>
                <a:cs typeface="Calibri" panose="020F0502020204030204" pitchFamily="34" charset="0"/>
              </a:rPr>
              <a:t>CVD (n=22), 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2) 1 ≤ known risk factor </a:t>
            </a:r>
            <a:r>
              <a:rPr lang="en-US" altLang="en-US" sz="1600" smtClean="0">
                <a:latin typeface="Calibri" panose="020F0502020204030204" pitchFamily="34" charset="0"/>
                <a:cs typeface="Calibri" panose="020F0502020204030204" pitchFamily="34" charset="0"/>
              </a:rPr>
              <a:t>for </a:t>
            </a:r>
            <a:r>
              <a:rPr lang="en-US" altLang="en-US" sz="1600" smtClean="0">
                <a:latin typeface="Calibri" panose="020F0502020204030204" pitchFamily="34" charset="0"/>
                <a:cs typeface="Calibri" panose="020F0502020204030204" pitchFamily="34" charset="0"/>
              </a:rPr>
              <a:t>CVD (n=24) 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or 3) known prior myocardial infarction, stroke </a:t>
            </a:r>
            <a:r>
              <a:rPr lang="en-US" altLang="en-US" sz="1600" smtClean="0">
                <a:latin typeface="Calibri" panose="020F0502020204030204" pitchFamily="34" charset="0"/>
                <a:cs typeface="Calibri" panose="020F0502020204030204" pitchFamily="34" charset="0"/>
              </a:rPr>
              <a:t>or </a:t>
            </a:r>
            <a:r>
              <a:rPr lang="en-US" altLang="en-US" sz="1600" smtClean="0">
                <a:latin typeface="Calibri" panose="020F0502020204030204" pitchFamily="34" charset="0"/>
                <a:cs typeface="Calibri" panose="020F0502020204030204" pitchFamily="34" charset="0"/>
              </a:rPr>
              <a:t>TIA (n=33).</a:t>
            </a:r>
            <a:endParaRPr lang="en-US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000" dirty="0" smtClean="0">
                <a:latin typeface="Calibri" panose="020F0502020204030204" pitchFamily="34" charset="0"/>
                <a:cs typeface="Calibri" panose="020F0502020204030204" pitchFamily="34" charset="0"/>
              </a:rPr>
              <a:t>Study </a:t>
            </a:r>
            <a:r>
              <a:rPr lang="en-US" alt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endpoints:</a:t>
            </a:r>
          </a:p>
          <a:p>
            <a:pPr marL="685800" lvl="1"/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Primary end 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point:</a:t>
            </a:r>
          </a:p>
          <a:p>
            <a:pPr marL="400050" lvl="1" indent="0">
              <a:buNone/>
            </a:pPr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	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Difference in </a:t>
            </a:r>
            <a:r>
              <a:rPr lang="en-US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[</a:t>
            </a:r>
            <a:r>
              <a:rPr lang="en-US" altLang="en-US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Cu]Cu-DOTATATE 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PET uptake measures of the carotid arteries and 	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aorta between groups. 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PET uptake measures were reported as SUV and TBR values.</a:t>
            </a:r>
            <a:endParaRPr lang="en-US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685800" lvl="1"/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Secondary end </a:t>
            </a:r>
            <a:r>
              <a:rPr lang="en-US" altLang="en-US" sz="1800" dirty="0" smtClean="0">
                <a:latin typeface="Calibri" panose="020F0502020204030204" pitchFamily="34" charset="0"/>
                <a:cs typeface="Calibri" panose="020F0502020204030204" pitchFamily="34" charset="0"/>
              </a:rPr>
              <a:t>points:</a:t>
            </a:r>
          </a:p>
          <a:p>
            <a:pPr marL="400050" lvl="1" indent="0">
              <a:buNone/>
            </a:pPr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	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Reproducibility measures of the vascular uptake metrics reported as ICC and Bland-	Altman 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plots.</a:t>
            </a:r>
            <a:b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	Receiver 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operating characteristics are </a:t>
            </a:r>
            <a:r>
              <a:rPr lang="en-US" alt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used to asses the ability of the different 	uptake metrics to discriminate between patients with no CVD and known CVD.</a:t>
            </a:r>
            <a:endParaRPr lang="en-US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19405" y="722902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RESULTS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033856" y="667884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026" name="Picture 2" descr="Figure 3 - Carotid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904" y="1301448"/>
            <a:ext cx="4415226" cy="3624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 descr="Figure 4 - Aorta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9125" y="1340767"/>
            <a:ext cx="4403083" cy="35541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3" name="Straight Connector 12"/>
          <p:cNvCxnSpPr/>
          <p:nvPr/>
        </p:nvCxnSpPr>
        <p:spPr>
          <a:xfrm>
            <a:off x="4534205" y="1444256"/>
            <a:ext cx="0" cy="50719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699125" y="4894926"/>
            <a:ext cx="4301232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Aortic </a:t>
            </a:r>
            <a:r>
              <a:rPr lang="en-US" sz="900" b="1" dirty="0">
                <a:latin typeface="Calibri" panose="020F0502020204030204" pitchFamily="34" charset="0"/>
                <a:cs typeface="Calibri" panose="020F0502020204030204" pitchFamily="34" charset="0"/>
              </a:rPr>
              <a:t>[</a:t>
            </a:r>
            <a:r>
              <a:rPr lang="en-US" sz="900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sz="900" b="1" dirty="0">
                <a:latin typeface="Calibri" panose="020F0502020204030204" pitchFamily="34" charset="0"/>
                <a:cs typeface="Calibri" panose="020F0502020204030204" pitchFamily="34" charset="0"/>
              </a:rPr>
              <a:t>Cu]Cu-DOTATATE PET/CT uptake </a:t>
            </a:r>
            <a:r>
              <a:rPr lang="en-US" sz="9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metrics</a:t>
            </a:r>
            <a:endParaRPr 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Scatter plots showing both SUV (A-C) and TBR (D-F) uptake metrics of the aorta, with </a:t>
            </a:r>
            <a:r>
              <a:rPr lang="en-US" sz="900" dirty="0" smtClean="0">
                <a:latin typeface="Calibri" panose="020F0502020204030204" pitchFamily="34" charset="0"/>
                <a:cs typeface="Calibri" panose="020F0502020204030204" pitchFamily="34" charset="0"/>
              </a:rPr>
              <a:t>means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± SD of the 3 groups. After adjustment of co-variates (age, </a:t>
            </a:r>
            <a:r>
              <a:rPr lang="en-US" sz="900" dirty="0" smtClean="0">
                <a:latin typeface="Calibri" panose="020F0502020204030204" pitchFamily="34" charset="0"/>
                <a:cs typeface="Calibri" panose="020F0502020204030204" pitchFamily="34" charset="0"/>
              </a:rPr>
              <a:t>sex, BMI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and smoking history</a:t>
            </a:r>
            <a:r>
              <a:rPr lang="en-US" sz="900" dirty="0" smtClean="0">
                <a:latin typeface="Calibri" panose="020F0502020204030204" pitchFamily="34" charset="0"/>
                <a:cs typeface="Calibri" panose="020F0502020204030204" pitchFamily="34" charset="0"/>
              </a:rPr>
              <a:t>). in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the multivariate model, TBR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ds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 was the only uptake metric observed to be </a:t>
            </a:r>
            <a:r>
              <a:rPr lang="en-US" sz="900" dirty="0" smtClean="0">
                <a:latin typeface="Calibri" panose="020F0502020204030204" pitchFamily="34" charset="0"/>
                <a:cs typeface="Calibri" panose="020F0502020204030204" pitchFamily="34" charset="0"/>
              </a:rPr>
              <a:t>significantly different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between the controls and known CVD group (p=0.04).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39420" y="4894926"/>
            <a:ext cx="430123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Difference </a:t>
            </a:r>
            <a:r>
              <a:rPr lang="en-US" sz="900" b="1" dirty="0">
                <a:latin typeface="Calibri" panose="020F0502020204030204" pitchFamily="34" charset="0"/>
                <a:cs typeface="Calibri" panose="020F0502020204030204" pitchFamily="34" charset="0"/>
              </a:rPr>
              <a:t>between groups in carotid [</a:t>
            </a:r>
            <a:r>
              <a:rPr lang="en-US" sz="900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sz="900" b="1" dirty="0">
                <a:latin typeface="Calibri" panose="020F0502020204030204" pitchFamily="34" charset="0"/>
                <a:cs typeface="Calibri" panose="020F0502020204030204" pitchFamily="34" charset="0"/>
              </a:rPr>
              <a:t>Cu]Cu-DOTATATE PET/CT uptake metrics was more pronounced compared to the </a:t>
            </a:r>
            <a:r>
              <a:rPr lang="en-US" sz="9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aorta</a:t>
            </a:r>
            <a:endParaRPr 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Scatter plots showing both SUV (A-C) and TBR (D-F) uptake metrics of the </a:t>
            </a:r>
            <a:r>
              <a:rPr lang="en-US" sz="900" dirty="0" smtClean="0">
                <a:latin typeface="Calibri" panose="020F0502020204030204" pitchFamily="34" charset="0"/>
                <a:cs typeface="Calibri" panose="020F0502020204030204" pitchFamily="34" charset="0"/>
              </a:rPr>
              <a:t>carotid arteries,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visualized as means ± SD of the 3 groups. Analyses of uptake metrics, after adjustment of co-variates, in carotid arteries showed a better ability to discriminate between groups compared to the analyses of the aorta. SUV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ax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 (p=0.03), SUV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ds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(p=0.05), TBR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ax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(p&lt;0.01), mTBR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ax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 (p=0.01) and TBR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ds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 (p&lt;0.01) all showed a significant difference between the controls and known CVD group. No difference was observed with regards to group difference in mSUV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ax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. The SUV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ax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 (p=0.02) and SUV</a:t>
            </a:r>
            <a:r>
              <a:rPr lang="en-US" sz="9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mds 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(p=0.03) was also different between the At-Risk and known CVD groups.</a:t>
            </a:r>
          </a:p>
          <a:p>
            <a:r>
              <a:rPr lang="en-US" sz="900" dirty="0" err="1">
                <a:latin typeface="Calibri" panose="020F0502020204030204" pitchFamily="34" charset="0"/>
                <a:cs typeface="Calibri" panose="020F0502020204030204" pitchFamily="34" charset="0"/>
              </a:rPr>
              <a:t>Mds</a:t>
            </a:r>
            <a:r>
              <a:rPr lang="en-US" sz="900" dirty="0">
                <a:latin typeface="Calibri" panose="020F0502020204030204" pitchFamily="34" charset="0"/>
                <a:cs typeface="Calibri" panose="020F0502020204030204" pitchFamily="34" charset="0"/>
              </a:rPr>
              <a:t>=most diseased segment; SUV=standardized uptake value; TBR=target-to-background-ratio.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RESULTS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 descr="DOTACOR_ROC-01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560" y="1626378"/>
            <a:ext cx="5376062" cy="4273877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2" name="Straight Connector 11"/>
          <p:cNvCxnSpPr/>
          <p:nvPr/>
        </p:nvCxnSpPr>
        <p:spPr>
          <a:xfrm>
            <a:off x="5029200" y="1752600"/>
            <a:ext cx="0" cy="381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5199836" y="1752600"/>
            <a:ext cx="29718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Receiver 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operating characteristic </a:t>
            </a:r>
            <a:r>
              <a:rPr lang="en-US" sz="12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curves</a:t>
            </a:r>
            <a:endParaRPr 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Receiver operating characteristic curves with AUC estimates and corresponding 95% confidence intervals between the controls and known CVD groups for measures where a significant difference was </a:t>
            </a:r>
            <a:r>
              <a:rPr lang="en-US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observed in the multivariate analyses. 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Best AUC measures were observed for the TBR metrics.</a:t>
            </a:r>
          </a:p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UC=area under the </a:t>
            </a:r>
            <a:r>
              <a:rPr lang="en-US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curve, other abbreviations as in previous figures.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CONCLUSIONS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endParaRPr lang="en-US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In 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the present study we were able to demonstrate differences in some of the most frequently reported PET uptake metrics using [</a:t>
            </a:r>
            <a:r>
              <a:rPr lang="en-US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Cu]Cu-DOTATATE as a marker of atherosclerotic inflammation in patients with different degrees of known 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CVD</a:t>
            </a:r>
            <a:b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endParaRPr lang="en-US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Measurements of the carotid artery as either maximum uptake values or most-diseased segment analysis, showed the best ability to discriminate between the groups</a:t>
            </a:r>
            <a: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br>
              <a:rPr lang="en-US" sz="1600" dirty="0" smtClean="0">
                <a:latin typeface="Calibri" panose="020F0502020204030204" pitchFamily="34" charset="0"/>
                <a:cs typeface="Calibri" panose="020F0502020204030204" pitchFamily="34" charset="0"/>
              </a:rPr>
            </a:br>
            <a:endParaRPr lang="en-US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The present study paves the way for further prospective investigations to validate and establish the value of [</a:t>
            </a:r>
            <a:r>
              <a:rPr lang="en-US" altLang="en-US" sz="16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64</a:t>
            </a:r>
            <a:r>
              <a:rPr lang="en-US" altLang="en-US" sz="1600" dirty="0">
                <a:latin typeface="Calibri" panose="020F0502020204030204" pitchFamily="34" charset="0"/>
                <a:cs typeface="Calibri" panose="020F0502020204030204" pitchFamily="34" charset="0"/>
              </a:rPr>
              <a:t>Cu]Cu-DOTATATE PET as a method for imaging and quantifying macrophage burden and thereby inflammation in atherosclerosis</a:t>
            </a:r>
            <a:endParaRPr lang="en-US" altLang="en-US" sz="1600" dirty="0" smtClean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6</TotalTime>
  <Words>869</Words>
  <Application>Microsoft Office PowerPoint</Application>
  <PresentationFormat>On-screen Show (4:3)</PresentationFormat>
  <Paragraphs>50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[64Cu]Cu-DOTATATE PET metrics in the investigation of atherosclerotic inflammation in human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Jacob Kildevang Jensen</cp:lastModifiedBy>
  <cp:revision>125</cp:revision>
  <dcterms:created xsi:type="dcterms:W3CDTF">2011-04-18T21:44:13Z</dcterms:created>
  <dcterms:modified xsi:type="dcterms:W3CDTF">2022-07-22T09:24:54Z</dcterms:modified>
</cp:coreProperties>
</file>